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302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6902"/>
    <p:restoredTop sz="95827"/>
  </p:normalViewPr>
  <p:slideViewPr>
    <p:cSldViewPr snapToGrid="0" snapToObjects="1">
      <p:cViewPr varScale="1">
        <p:scale>
          <a:sx n="107" d="100"/>
          <a:sy n="107" d="100"/>
        </p:scale>
        <p:origin x="66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48737C7-4C75-EC44-9173-8EB2CD974C1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DBE706A6-BB85-124A-8ED9-3CBC5C60226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3193FF0-39B5-8745-8CBC-4486276573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AB2258-BD71-CE43-B49D-4E337B4A532E}" type="datetimeFigureOut">
              <a:rPr kumimoji="1" lang="zh-CN" altLang="en-US" smtClean="0"/>
              <a:t>2022/7/30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8D51D07-2004-344A-8256-3F8E5AD49D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9D0DB79-4197-3549-AAA7-F019802D7C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90C3D-6AF8-E541-B6C1-0997302DE347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2040831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06BB643-11B6-894D-9452-66A033D158F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1BB4303B-E885-F543-BC10-F88C400B688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64811CD-DEDE-BE45-A6EC-0B4A4B124F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AB2258-BD71-CE43-B49D-4E337B4A532E}" type="datetimeFigureOut">
              <a:rPr kumimoji="1" lang="zh-CN" altLang="en-US" smtClean="0"/>
              <a:t>2022/7/30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D9E786E-56E2-EF40-A152-6429A68136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7348999-3DD7-0D43-A623-60E921D261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90C3D-6AF8-E541-B6C1-0997302DE347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7434161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244BE53B-A50E-0E41-B9BC-A62D96387B7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B136E87E-A6BC-BE4C-987D-20894D43186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DC7F5C2-3B3C-6445-9889-6BB2D437CC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AB2258-BD71-CE43-B49D-4E337B4A532E}" type="datetimeFigureOut">
              <a:rPr kumimoji="1" lang="zh-CN" altLang="en-US" smtClean="0"/>
              <a:t>2022/7/30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63C966B-9974-0248-B432-AEA966C545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FDE0D3F-86E6-AF4B-BC73-34AB71F558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90C3D-6AF8-E541-B6C1-0997302DE347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9413267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C92FA4D-105C-514E-93F0-3B439053DA5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4768B90E-FC90-0C44-BDC8-D690AADD4E3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E9CAF84-8DEE-644B-BDB7-616D1CED25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AB2258-BD71-CE43-B49D-4E337B4A532E}" type="datetimeFigureOut">
              <a:rPr kumimoji="1" lang="zh-CN" altLang="en-US" smtClean="0"/>
              <a:t>2022/7/30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F32097B-403E-E246-B8E3-949B6AFA61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B54EC01-756F-C845-960B-CBC90B08EB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90C3D-6AF8-E541-B6C1-0997302DE347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6138605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6C21940-B47D-194D-9892-E6D982B0E7A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22C333C2-FFD5-6E46-B908-82808F5278F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74B4990-5572-5644-9D0A-5331A5276D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AB2258-BD71-CE43-B49D-4E337B4A532E}" type="datetimeFigureOut">
              <a:rPr kumimoji="1" lang="zh-CN" altLang="en-US" smtClean="0"/>
              <a:t>2022/7/30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CA91566-7082-6945-8834-FFEA9BAE84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CC96B20-E10D-D94E-9B17-573DBECA07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90C3D-6AF8-E541-B6C1-0997302DE347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337136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207F4EC-C31B-6D47-852D-25B87B374FE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187C3537-000C-5645-BD98-8C8FD9FB6C6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7A534CC3-E0C7-9B42-BE4C-BFBE8E3EDAA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E1DD1223-577A-7D4E-BD6A-A0CF210B36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AB2258-BD71-CE43-B49D-4E337B4A532E}" type="datetimeFigureOut">
              <a:rPr kumimoji="1" lang="zh-CN" altLang="en-US" smtClean="0"/>
              <a:t>2022/7/30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BC75D77A-0817-AD4E-BE6F-A57F3A82BA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B6179118-9A9F-3447-B7F7-0FD626E6BE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90C3D-6AF8-E541-B6C1-0997302DE347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6973656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133D81C-080F-C845-A19D-1F3852673EF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2F719A37-EA2E-4A4D-A59D-AAAD8F4143B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F1D12A82-56AD-C54B-BE53-D778AA03E89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94884769-99EA-2A41-9203-A3058FF194D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4B7DC334-A453-C34E-A1F3-F53FBF1F3B9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6756BCBB-3C7F-5A44-BADC-BAAB43F5BF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AB2258-BD71-CE43-B49D-4E337B4A532E}" type="datetimeFigureOut">
              <a:rPr kumimoji="1" lang="zh-CN" altLang="en-US" smtClean="0"/>
              <a:t>2022/7/30</a:t>
            </a:fld>
            <a:endParaRPr kumimoji="1"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72EE216C-319A-FD4E-A2B2-7EC910779A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1E28BBCF-96E5-D248-8938-1E5D7EE3DD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90C3D-6AF8-E541-B6C1-0997302DE347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5510843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E7FFF27-EDCD-094C-B1C1-3B025057FA8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29630326-DF8A-5440-A7F3-B2B9640EFF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AB2258-BD71-CE43-B49D-4E337B4A532E}" type="datetimeFigureOut">
              <a:rPr kumimoji="1" lang="zh-CN" altLang="en-US" smtClean="0"/>
              <a:t>2022/7/30</a:t>
            </a:fld>
            <a:endParaRPr kumimoji="1"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958B200D-5DD5-0B46-9FEE-36CAA8B74C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1AE8F8D4-67CC-B24A-B2CB-9A51A5C368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90C3D-6AF8-E541-B6C1-0997302DE347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2894781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4C25452C-BFF5-3C42-8AE5-00F4CD89D5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AB2258-BD71-CE43-B49D-4E337B4A532E}" type="datetimeFigureOut">
              <a:rPr kumimoji="1" lang="zh-CN" altLang="en-US" smtClean="0"/>
              <a:t>2022/7/30</a:t>
            </a:fld>
            <a:endParaRPr kumimoji="1"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B31F5C2C-BB32-A94E-8408-C95B733762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04577415-AD7D-7A43-BF89-A3072F0DA5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90C3D-6AF8-E541-B6C1-0997302DE347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1851649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C9C36CA-D466-B940-84A3-22D182BA03F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547F5141-CB8E-294E-8391-76ECE447BF9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25C41D91-758C-FB48-BF24-E51F6D92604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26CDB4B1-D63A-5B43-8208-BA4A27ACEB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AB2258-BD71-CE43-B49D-4E337B4A532E}" type="datetimeFigureOut">
              <a:rPr kumimoji="1" lang="zh-CN" altLang="en-US" smtClean="0"/>
              <a:t>2022/7/30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1F905CE4-6A03-CF42-B482-1DDA4D4EF7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1EDD9A73-2243-4648-9323-4E20D879F8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90C3D-6AF8-E541-B6C1-0997302DE347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9721802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E220626-8A1D-6240-A4C7-024280A31A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08E3B750-BA2F-824E-ADB3-20DC05509EC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6D5C69A8-46EE-6847-A167-10436E7441F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A2C68C19-23A7-4245-B4E1-15D0627A3D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AB2258-BD71-CE43-B49D-4E337B4A532E}" type="datetimeFigureOut">
              <a:rPr kumimoji="1" lang="zh-CN" altLang="en-US" smtClean="0"/>
              <a:t>2022/7/30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BF8CA207-5865-6946-8C13-A304B07D9D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804534A1-DA1E-7246-940F-5ADA0F0AF7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90C3D-6AF8-E541-B6C1-0997302DE347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862891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DC550802-AE60-F24F-898A-5078D237D2C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20E52D8D-0893-E14C-9817-8E661FD08ED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A01BB92-5AD4-D641-83EC-67AF064BBBC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AB2258-BD71-CE43-B49D-4E337B4A532E}" type="datetimeFigureOut">
              <a:rPr kumimoji="1" lang="zh-CN" altLang="en-US" smtClean="0"/>
              <a:t>2022/7/30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371398A-38CF-664B-A739-9020255E143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0CC9030-C533-1D4F-8481-98426766E80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690C3D-6AF8-E541-B6C1-0997302DE347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9463178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hyperlink" Target="http://www.mbkbase.org/" TargetMode="Externa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组合 2"/>
          <p:cNvGrpSpPr>
            <a:grpSpLocks noChangeAspect="1"/>
          </p:cNvGrpSpPr>
          <p:nvPr/>
        </p:nvGrpSpPr>
        <p:grpSpPr>
          <a:xfrm>
            <a:off x="1088098" y="977247"/>
            <a:ext cx="10015805" cy="2479382"/>
            <a:chOff x="730611" y="699155"/>
            <a:chExt cx="10800000" cy="2673508"/>
          </a:xfrm>
        </p:grpSpPr>
        <p:grpSp>
          <p:nvGrpSpPr>
            <p:cNvPr id="2" name="组合 1">
              <a:extLst>
                <a:ext uri="{FF2B5EF4-FFF2-40B4-BE49-F238E27FC236}">
                  <a16:creationId xmlns:a16="http://schemas.microsoft.com/office/drawing/2014/main" id="{C4207A6B-21B8-AC97-DC02-F9E0E929779C}"/>
                </a:ext>
              </a:extLst>
            </p:cNvPr>
            <p:cNvGrpSpPr/>
            <p:nvPr/>
          </p:nvGrpSpPr>
          <p:grpSpPr>
            <a:xfrm>
              <a:off x="730611" y="1167485"/>
              <a:ext cx="10800000" cy="2205178"/>
              <a:chOff x="643944" y="779922"/>
              <a:chExt cx="10800000" cy="2205178"/>
            </a:xfrm>
          </p:grpSpPr>
          <p:pic>
            <p:nvPicPr>
              <p:cNvPr id="5" name="图片 4">
                <a:extLst>
                  <a:ext uri="{FF2B5EF4-FFF2-40B4-BE49-F238E27FC236}">
                    <a16:creationId xmlns:a16="http://schemas.microsoft.com/office/drawing/2014/main" id="{168C99CE-B39F-7972-C95E-16C01F21EA4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643944" y="779922"/>
                <a:ext cx="10800000" cy="1692825"/>
              </a:xfrm>
              <a:prstGeom prst="rect">
                <a:avLst/>
              </a:prstGeom>
            </p:spPr>
          </p:pic>
          <p:pic>
            <p:nvPicPr>
              <p:cNvPr id="7" name="图片 6">
                <a:extLst>
                  <a:ext uri="{FF2B5EF4-FFF2-40B4-BE49-F238E27FC236}">
                    <a16:creationId xmlns:a16="http://schemas.microsoft.com/office/drawing/2014/main" id="{6BDDB794-02D4-1AE2-8A7C-DBA3E44FF86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t="70738" r="2353" b="885"/>
              <a:stretch/>
            </p:blipFill>
            <p:spPr>
              <a:xfrm>
                <a:off x="668168" y="2505461"/>
                <a:ext cx="10537200" cy="479639"/>
              </a:xfrm>
              <a:prstGeom prst="rect">
                <a:avLst/>
              </a:prstGeom>
            </p:spPr>
          </p:pic>
        </p:grpSp>
        <p:pic>
          <p:nvPicPr>
            <p:cNvPr id="11" name="图片 10">
              <a:extLst>
                <a:ext uri="{FF2B5EF4-FFF2-40B4-BE49-F238E27FC236}">
                  <a16:creationId xmlns:a16="http://schemas.microsoft.com/office/drawing/2014/main" id="{091B7262-9F7B-4445-D778-25CCBD3489CD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036000" y="699155"/>
              <a:ext cx="6120000" cy="429760"/>
            </a:xfrm>
            <a:prstGeom prst="rect">
              <a:avLst/>
            </a:prstGeom>
          </p:spPr>
        </p:pic>
      </p:grpSp>
      <p:sp>
        <p:nvSpPr>
          <p:cNvPr id="14" name="文本框 13">
            <a:extLst>
              <a:ext uri="{FF2B5EF4-FFF2-40B4-BE49-F238E27FC236}">
                <a16:creationId xmlns:a16="http://schemas.microsoft.com/office/drawing/2014/main" id="{6FEF7726-AB1E-9918-8635-03856EE3C543}"/>
              </a:ext>
            </a:extLst>
          </p:cNvPr>
          <p:cNvSpPr txBox="1"/>
          <p:nvPr/>
        </p:nvSpPr>
        <p:spPr>
          <a:xfrm>
            <a:off x="946673" y="4221321"/>
            <a:ext cx="10298654" cy="90794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7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pression pattern of candidate genes of </a:t>
            </a:r>
            <a:r>
              <a:rPr lang="zh-CN" alt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q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MN10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zh-CN" altLang="en-US" sz="12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spcBef>
                <a:spcPts val="600"/>
              </a:spcBef>
            </a:pP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 expression profiles in various tissues at different developmental ages or cells, and the data were obtained from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  <a:hlinkClick r:id="rId5"/>
              </a:rPr>
              <a:t>http://www.mbkbase.org/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FPKM, Fragments Per 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ilobase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er Million, indicates gene expression level. Milk, filling and mature represent the developmental stages of rice grain. G-ale indicates grain 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leurone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g-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m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dicates grain embryo and g-ES indicates grain endosperm.</a:t>
            </a:r>
          </a:p>
        </p:txBody>
      </p:sp>
    </p:spTree>
    <p:extLst>
      <p:ext uri="{BB962C8B-B14F-4D97-AF65-F5344CB8AC3E}">
        <p14:creationId xmlns:p14="http://schemas.microsoft.com/office/powerpoint/2010/main" val="19351937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78</Words>
  <Application>Microsoft Macintosh PowerPoint</Application>
  <PresentationFormat>宽屏</PresentationFormat>
  <Paragraphs>2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Times New Roman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icrosoft Office 用户</dc:creator>
  <cp:lastModifiedBy>Microsoft Office 用户</cp:lastModifiedBy>
  <cp:revision>3</cp:revision>
  <dcterms:created xsi:type="dcterms:W3CDTF">2022-07-23T07:53:04Z</dcterms:created>
  <dcterms:modified xsi:type="dcterms:W3CDTF">2022-07-30T12:41:32Z</dcterms:modified>
</cp:coreProperties>
</file>